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70C2A-8BEA-4CFF-A7F5-47E703F3EA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23D49-2771-466C-A4B7-5BFA124E85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CCE59-8527-4F3B-B0A7-9EC91CA7D9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6F606-89FF-4F4F-90F2-9F142BE635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F0867-9D6A-46D1-BFEE-DF18AFB6CB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A3659C-3B7F-4D7A-B737-C843A911FC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9135C2-9C9F-4659-995F-C46EB61F70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24FF05-74E2-4243-B606-BCAA70D051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E04FE-5FDC-4B2A-8B3D-25C6D4E3E8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669DCF-A8D8-465D-AB4F-AA5A62CD29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4FF47-E0EE-49B7-AB39-CBD4A7601A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FEEA0-6F1B-4040-A879-BFC36E95AA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8A4A21-A0EC-4009-946C-8F483F407D85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33560" y="1052640"/>
            <a:ext cx="6208560" cy="3343320"/>
            <a:chOff x="1033560" y="1052640"/>
            <a:chExt cx="6208560" cy="3343320"/>
          </a:xfrm>
        </p:grpSpPr>
        <p:sp>
          <p:nvSpPr>
            <p:cNvPr id="42" name=""/>
            <p:cNvSpPr/>
            <p:nvPr/>
          </p:nvSpPr>
          <p:spPr>
            <a:xfrm>
              <a:off x="6296040" y="4076640"/>
              <a:ext cx="7650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5221440" y="4083120"/>
              <a:ext cx="100008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97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78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140360" y="4076640"/>
              <a:ext cx="95868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131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63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916360" y="4076640"/>
              <a:ext cx="119988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,059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</a:rPr>
                <a:t>±10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062000" y="4076640"/>
              <a:ext cx="93672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iv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227640" y="3803760"/>
              <a:ext cx="81468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221440" y="3809880"/>
              <a:ext cx="100008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174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8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197240" y="3803760"/>
              <a:ext cx="88740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558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87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184560" y="3803760"/>
              <a:ext cx="8589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,416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8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062000" y="3803760"/>
              <a:ext cx="93672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227640" y="3530520"/>
              <a:ext cx="81468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324400" y="3537000"/>
              <a:ext cx="100008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708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,69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267080" y="3530520"/>
              <a:ext cx="81612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70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2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22720" y="3530520"/>
              <a:ext cx="8175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903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24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062000" y="3530520"/>
              <a:ext cx="93672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HM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321600" y="3257640"/>
              <a:ext cx="84744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72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49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313240" y="3263760"/>
              <a:ext cx="10782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,087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,52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Ŧ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119480" y="3257640"/>
              <a:ext cx="93204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520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059280" y="3257640"/>
              <a:ext cx="109512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,903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,3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062000" y="3257640"/>
              <a:ext cx="93672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GM199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427800" y="2801880"/>
              <a:ext cx="814320" cy="45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dium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451480" y="2808360"/>
              <a:ext cx="100008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v262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300560" y="2801880"/>
              <a:ext cx="814320" cy="45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v2627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290760" y="2801880"/>
              <a:ext cx="816120" cy="45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v2626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117440" y="4343400"/>
              <a:ext cx="5237280" cy="1260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062000" y="2801880"/>
              <a:ext cx="0" cy="154800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418440" y="2801880"/>
              <a:ext cx="0" cy="154800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021040" y="4081320"/>
              <a:ext cx="9252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,370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5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925640" y="3808440"/>
              <a:ext cx="11271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3,262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,56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886040" y="3535200"/>
              <a:ext cx="103644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,899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54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035080" y="3262320"/>
              <a:ext cx="114480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4,926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,087</a:t>
              </a:r>
              <a:r>
                <a:rPr b="0" lang="el-GR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Ŧ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238480" y="2806560"/>
              <a:ext cx="815760" cy="45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v1733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082520" y="4395960"/>
              <a:ext cx="6159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161040" y="2516040"/>
              <a:ext cx="8571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435640" y="2516040"/>
              <a:ext cx="7794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172040" y="2516040"/>
              <a:ext cx="9795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13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22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881360" y="2522520"/>
              <a:ext cx="113472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068480" y="2525760"/>
              <a:ext cx="9363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aiv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426360" y="2243160"/>
              <a:ext cx="59184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346720" y="2243160"/>
              <a:ext cx="85572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4135320" y="2243160"/>
              <a:ext cx="93672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4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28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797120" y="2249640"/>
              <a:ext cx="12873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0,000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75,98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068480" y="2252520"/>
              <a:ext cx="9363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197760" y="1960560"/>
              <a:ext cx="8157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lt;5 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994280" y="1969920"/>
              <a:ext cx="12114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,170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2,6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464000" y="1969920"/>
              <a:ext cx="5079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.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590840" y="1976400"/>
              <a:ext cx="149544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46,767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40,7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068480" y="1979640"/>
              <a:ext cx="9363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M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965840" y="1697040"/>
              <a:ext cx="14205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</a:t>
              </a:r>
              <a:r>
                <a:rPr b="0" lang="fr-F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3,103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2,828</a:t>
              </a:r>
              <a:r>
                <a:rPr b="0" lang="el-GR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995640" y="1700280"/>
              <a:ext cx="1268640" cy="269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,417 ±6488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*Ŧ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760400" y="1703520"/>
              <a:ext cx="145764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250,833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30,005</a:t>
              </a:r>
              <a:r>
                <a:rPr b="0" lang="el-GR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068480" y="1706400"/>
              <a:ext cx="93636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GM199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6383160" y="1251000"/>
              <a:ext cx="81468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di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383080" y="1251000"/>
              <a:ext cx="100008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SAT6 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1-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211640" y="1251000"/>
              <a:ext cx="100800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85A 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41-2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270240" y="1251000"/>
              <a:ext cx="81612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200" spc="-1" strike="noStrike">
                  <a:solidFill>
                    <a:srgbClr val="000000"/>
                  </a:solidFill>
                  <a:latin typeface="Times New Roman"/>
                </a:rPr>
                <a:t>Ag85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068480" y="1251000"/>
              <a:ext cx="520056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068480" y="1251000"/>
              <a:ext cx="0" cy="154764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6202440" y="1251000"/>
              <a:ext cx="0" cy="154764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342240" y="1063800"/>
              <a:ext cx="1488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</a:rPr>
                <a:t>IFN-</a:t>
              </a:r>
              <a:r>
                <a:rPr b="1" lang="el-GR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γ</a:t>
              </a: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  <a:ea typeface="Arial"/>
                </a:rPr>
                <a:t> secretion</a:t>
              </a: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</a:rPr>
                <a:t> pg/m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062360" y="1425600"/>
              <a:ext cx="578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100" spc="-1" strike="noStrike">
                  <a:solidFill>
                    <a:srgbClr val="000000"/>
                  </a:solidFill>
                  <a:latin typeface="Times New Roman"/>
                </a:rPr>
                <a:t>Grou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040200" y="2519280"/>
              <a:ext cx="102852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88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62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862360" y="2246400"/>
              <a:ext cx="119700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269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</a:t>
              </a: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5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975040" y="1973160"/>
              <a:ext cx="1197000" cy="27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,044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</a:t>
              </a: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2,08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909880" y="1700280"/>
              <a:ext cx="137016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</a:rPr>
                <a:t>18,185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6,818</a:t>
              </a:r>
              <a:r>
                <a:rPr b="0" lang="el-GR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Ψ</a:t>
              </a:r>
              <a:r>
                <a:rPr b="0" lang="fr-BE" sz="11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239920" y="1254240"/>
              <a:ext cx="816120" cy="45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BE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P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033560" y="1052640"/>
              <a:ext cx="6159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042920" y="1706400"/>
              <a:ext cx="6159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049480" y="2905200"/>
              <a:ext cx="513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039760" y="1360440"/>
              <a:ext cx="512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062000" y="3257640"/>
              <a:ext cx="6159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6221520" y="1697040"/>
              <a:ext cx="931680" cy="27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BE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72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±149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"/>
          <p:cNvSpPr/>
          <p:nvPr/>
        </p:nvSpPr>
        <p:spPr>
          <a:xfrm>
            <a:off x="902520" y="614520"/>
            <a:ext cx="1093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8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6T08:02:04Z</dcterms:created>
  <dc:creator>ISP-WIV</dc:creator>
  <dc:description/>
  <dc:language>en-US</dc:language>
  <cp:lastModifiedBy>ISP-WIV</cp:lastModifiedBy>
  <dcterms:modified xsi:type="dcterms:W3CDTF">2013-08-06T08:02:09Z</dcterms:modified>
  <cp:revision>1</cp:revision>
  <dc:subject/>
  <dc:title>Diapositive 1</dc:title>
</cp:coreProperties>
</file>